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0" autoAdjust="0"/>
    <p:restoredTop sz="94660"/>
  </p:normalViewPr>
  <p:slideViewPr>
    <p:cSldViewPr snapToGrid="0">
      <p:cViewPr varScale="1">
        <p:scale>
          <a:sx n="60" d="100"/>
          <a:sy n="60" d="100"/>
        </p:scale>
        <p:origin x="72" y="10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E$3:$E$18</c:f>
                <c:numCache>
                  <c:formatCode>General</c:formatCode>
                  <c:ptCount val="16"/>
                  <c:pt idx="0">
                    <c:v>0.96325368829307101</c:v>
                  </c:pt>
                  <c:pt idx="1">
                    <c:v>1.100861358049233</c:v>
                  </c:pt>
                  <c:pt idx="2">
                    <c:v>1.9265073765861409</c:v>
                  </c:pt>
                  <c:pt idx="3">
                    <c:v>0.825646018536908</c:v>
                  </c:pt>
                  <c:pt idx="4">
                    <c:v>1.5136843673176821</c:v>
                  </c:pt>
                  <c:pt idx="5">
                    <c:v>0.68803834878076398</c:v>
                  </c:pt>
                  <c:pt idx="6">
                    <c:v>1.6512920370738451</c:v>
                  </c:pt>
                  <c:pt idx="7">
                    <c:v>1.7888997068299981</c:v>
                  </c:pt>
                  <c:pt idx="8">
                    <c:v>4.5410531019530573</c:v>
                  </c:pt>
                  <c:pt idx="9">
                    <c:v>1.6512920370738451</c:v>
                  </c:pt>
                  <c:pt idx="10">
                    <c:v>2.064115046342315</c:v>
                  </c:pt>
                  <c:pt idx="11">
                    <c:v>0.13760766975615299</c:v>
                  </c:pt>
                  <c:pt idx="12">
                    <c:v>0.27521533951230598</c:v>
                  </c:pt>
                  <c:pt idx="13">
                    <c:v>12.52229794780996</c:v>
                  </c:pt>
                  <c:pt idx="14">
                    <c:v>1.5136843673176921</c:v>
                  </c:pt>
                </c:numCache>
              </c:numRef>
            </c:plus>
            <c:minus>
              <c:numRef>
                <c:f>Sheet1!$E$3:$E$17</c:f>
                <c:numCache>
                  <c:formatCode>General</c:formatCode>
                  <c:ptCount val="15"/>
                  <c:pt idx="0">
                    <c:v>0.96325368829307101</c:v>
                  </c:pt>
                  <c:pt idx="1">
                    <c:v>1.100861358049233</c:v>
                  </c:pt>
                  <c:pt idx="2">
                    <c:v>1.9265073765861409</c:v>
                  </c:pt>
                  <c:pt idx="3">
                    <c:v>0.825646018536908</c:v>
                  </c:pt>
                  <c:pt idx="4">
                    <c:v>1.5136843673176821</c:v>
                  </c:pt>
                  <c:pt idx="5">
                    <c:v>0.68803834878076398</c:v>
                  </c:pt>
                  <c:pt idx="6">
                    <c:v>1.6512920370738451</c:v>
                  </c:pt>
                  <c:pt idx="7">
                    <c:v>1.7888997068299981</c:v>
                  </c:pt>
                  <c:pt idx="8">
                    <c:v>4.5410531019530573</c:v>
                  </c:pt>
                  <c:pt idx="9">
                    <c:v>1.6512920370738451</c:v>
                  </c:pt>
                  <c:pt idx="10">
                    <c:v>2.064115046342315</c:v>
                  </c:pt>
                  <c:pt idx="11">
                    <c:v>0.13760766975615299</c:v>
                  </c:pt>
                  <c:pt idx="12">
                    <c:v>0.27521533951230598</c:v>
                  </c:pt>
                  <c:pt idx="13">
                    <c:v>12.52229794780996</c:v>
                  </c:pt>
                  <c:pt idx="14">
                    <c:v>1.51368436731769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1!$B$3:$C$17</c:f>
              <c:multiLvlStrCache>
                <c:ptCount val="15"/>
                <c:lvl>
                  <c:pt idx="0">
                    <c:v>AZD6422</c:v>
                  </c:pt>
                  <c:pt idx="1">
                    <c:v>AZD6422</c:v>
                  </c:pt>
                  <c:pt idx="2">
                    <c:v>AZD6422</c:v>
                  </c:pt>
                  <c:pt idx="3">
                    <c:v>IKKV</c:v>
                  </c:pt>
                  <c:pt idx="4">
                    <c:v>IKKV</c:v>
                  </c:pt>
                  <c:pt idx="5">
                    <c:v>IKKV</c:v>
                  </c:pt>
                  <c:pt idx="6">
                    <c:v>SB203580</c:v>
                  </c:pt>
                  <c:pt idx="7">
                    <c:v>SB203580</c:v>
                  </c:pt>
                  <c:pt idx="8">
                    <c:v>SB203580</c:v>
                  </c:pt>
                  <c:pt idx="9">
                    <c:v>SP600125</c:v>
                  </c:pt>
                  <c:pt idx="10">
                    <c:v>SP600125</c:v>
                  </c:pt>
                  <c:pt idx="11">
                    <c:v>SP600125</c:v>
                  </c:pt>
                  <c:pt idx="12">
                    <c:v>WP</c:v>
                  </c:pt>
                  <c:pt idx="13">
                    <c:v>WP</c:v>
                  </c:pt>
                  <c:pt idx="14">
                    <c:v>WP</c:v>
                  </c:pt>
                </c:lvl>
                <c:lvl>
                  <c:pt idx="0">
                    <c:v>50</c:v>
                  </c:pt>
                  <c:pt idx="1">
                    <c:v>25</c:v>
                  </c:pt>
                  <c:pt idx="2">
                    <c:v>10</c:v>
                  </c:pt>
                  <c:pt idx="3">
                    <c:v>25</c:v>
                  </c:pt>
                  <c:pt idx="4">
                    <c:v>10</c:v>
                  </c:pt>
                  <c:pt idx="5">
                    <c:v>5</c:v>
                  </c:pt>
                  <c:pt idx="6">
                    <c:v>50</c:v>
                  </c:pt>
                  <c:pt idx="7">
                    <c:v>25</c:v>
                  </c:pt>
                  <c:pt idx="8">
                    <c:v>10</c:v>
                  </c:pt>
                  <c:pt idx="9">
                    <c:v>50</c:v>
                  </c:pt>
                  <c:pt idx="10">
                    <c:v>25</c:v>
                  </c:pt>
                  <c:pt idx="11">
                    <c:v>10</c:v>
                  </c:pt>
                  <c:pt idx="12">
                    <c:v>5</c:v>
                  </c:pt>
                  <c:pt idx="13">
                    <c:v>2.5</c:v>
                  </c:pt>
                  <c:pt idx="14">
                    <c:v>1</c:v>
                  </c:pt>
                </c:lvl>
              </c:multiLvlStrCache>
            </c:multiLvlStrRef>
          </c:cat>
          <c:val>
            <c:numRef>
              <c:f>Sheet1!$D$3:$D$17</c:f>
              <c:numCache>
                <c:formatCode>General</c:formatCode>
                <c:ptCount val="15"/>
                <c:pt idx="0">
                  <c:v>106.9363447542128</c:v>
                </c:pt>
                <c:pt idx="1">
                  <c:v>103.72533531209351</c:v>
                </c:pt>
                <c:pt idx="2">
                  <c:v>105.47679500779491</c:v>
                </c:pt>
                <c:pt idx="3">
                  <c:v>113.8448802205905</c:v>
                </c:pt>
                <c:pt idx="4">
                  <c:v>121.9210554841025</c:v>
                </c:pt>
                <c:pt idx="5">
                  <c:v>112.3853304741727</c:v>
                </c:pt>
                <c:pt idx="6">
                  <c:v>95.551856732153723</c:v>
                </c:pt>
                <c:pt idx="7">
                  <c:v>92.535453922890241</c:v>
                </c:pt>
                <c:pt idx="8">
                  <c:v>103.43342536281</c:v>
                </c:pt>
                <c:pt idx="9">
                  <c:v>115.0125200177248</c:v>
                </c:pt>
                <c:pt idx="10">
                  <c:v>125.0347616097939</c:v>
                </c:pt>
                <c:pt idx="11">
                  <c:v>134.37587998686789</c:v>
                </c:pt>
                <c:pt idx="12">
                  <c:v>101.5846623506807</c:v>
                </c:pt>
                <c:pt idx="13">
                  <c:v>97.78983300999441</c:v>
                </c:pt>
                <c:pt idx="14">
                  <c:v>98.56825954141727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23996400"/>
        <c:axId val="124015384"/>
      </c:barChart>
      <c:catAx>
        <c:axId val="1239964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noFill/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24015384"/>
        <c:crosses val="autoZero"/>
        <c:auto val="1"/>
        <c:lblAlgn val="ctr"/>
        <c:lblOffset val="100"/>
        <c:noMultiLvlLbl val="0"/>
      </c:catAx>
      <c:valAx>
        <c:axId val="1240153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381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23996400"/>
        <c:crosses val="autoZero"/>
        <c:crossBetween val="between"/>
      </c:valAx>
      <c:spPr>
        <a:noFill/>
        <a:ln w="381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990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65208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6698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8309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652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2749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0556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753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51091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3151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5787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B5791A-D88B-431A-87B2-78E0BDE1A696}" type="datetimeFigureOut">
              <a:rPr lang="en-US" smtClean="0"/>
              <a:t>9/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1DC93-F4B4-4C68-B64E-686219DC28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2224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 rot="16200000">
            <a:off x="-13673" y="3223534"/>
            <a:ext cx="22451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Viability (% DMSO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205970" y="5535257"/>
            <a:ext cx="5148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 smtClean="0">
                <a:latin typeface="Symbol" panose="05050102010706020507" pitchFamily="18" charset="2"/>
              </a:rPr>
              <a:t>m</a:t>
            </a:r>
            <a:r>
              <a:rPr lang="en-US" b="1" dirty="0" err="1" smtClean="0"/>
              <a:t>M</a:t>
            </a:r>
            <a:endParaRPr 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2204637" y="6013670"/>
            <a:ext cx="93923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ZD 6244                IKK2V                SB203580            SP600125             WP1066            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4532504"/>
              </p:ext>
            </p:extLst>
          </p:nvPr>
        </p:nvGraphicFramePr>
        <p:xfrm>
          <a:off x="1303867" y="812799"/>
          <a:ext cx="9990666" cy="489373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1910990" y="5564725"/>
            <a:ext cx="91614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50      25      10      25      10      5       50      25     10      50      25      10       5      2.5      1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Straight Connector 8"/>
          <p:cNvCxnSpPr/>
          <p:nvPr/>
        </p:nvCxnSpPr>
        <p:spPr>
          <a:xfrm>
            <a:off x="1910990" y="5934057"/>
            <a:ext cx="1657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3824457" y="5941448"/>
            <a:ext cx="1657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5670190" y="5975317"/>
            <a:ext cx="1657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>
            <a:off x="7498987" y="5975320"/>
            <a:ext cx="1657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9429388" y="5992256"/>
            <a:ext cx="165740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0955764" y="19874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9690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28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yyavooLab</dc:creator>
  <cp:lastModifiedBy>AyyavooLab</cp:lastModifiedBy>
  <cp:revision>8</cp:revision>
  <dcterms:created xsi:type="dcterms:W3CDTF">2015-04-21T04:34:16Z</dcterms:created>
  <dcterms:modified xsi:type="dcterms:W3CDTF">2015-09-07T18:22:55Z</dcterms:modified>
</cp:coreProperties>
</file>